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3BF868D-224E-4873-BE58-D888B46218D2}" v="3" dt="2024-11-14T09:27:43.38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59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aqvi, Sadaf" userId="f5e58198-253e-46bf-aa45-1a14f3a6ceb6" providerId="ADAL" clId="{00D7346A-D00E-4A1D-869F-C86D36D9D78D}"/>
    <pc:docChg chg="undo custSel modSld">
      <pc:chgData name="Naqvi, Sadaf" userId="f5e58198-253e-46bf-aa45-1a14f3a6ceb6" providerId="ADAL" clId="{00D7346A-D00E-4A1D-869F-C86D36D9D78D}" dt="2023-08-04T10:29:01.953" v="69" actId="478"/>
      <pc:docMkLst>
        <pc:docMk/>
      </pc:docMkLst>
      <pc:sldChg chg="addSp delSp modSp mod">
        <pc:chgData name="Naqvi, Sadaf" userId="f5e58198-253e-46bf-aa45-1a14f3a6ceb6" providerId="ADAL" clId="{00D7346A-D00E-4A1D-869F-C86D36D9D78D}" dt="2023-08-04T10:29:01.953" v="69" actId="478"/>
        <pc:sldMkLst>
          <pc:docMk/>
          <pc:sldMk cId="116669129" sldId="257"/>
        </pc:sldMkLst>
        <pc:spChg chg="mod">
          <ac:chgData name="Naqvi, Sadaf" userId="f5e58198-253e-46bf-aa45-1a14f3a6ceb6" providerId="ADAL" clId="{00D7346A-D00E-4A1D-869F-C86D36D9D78D}" dt="2023-08-04T10:23:59.732" v="7" actId="1076"/>
          <ac:spMkLst>
            <pc:docMk/>
            <pc:sldMk cId="116669129" sldId="257"/>
            <ac:spMk id="14" creationId="{B74961BF-5ECE-8064-A8FC-A40A974A54CA}"/>
          </ac:spMkLst>
        </pc:spChg>
        <pc:spChg chg="add del">
          <ac:chgData name="Naqvi, Sadaf" userId="f5e58198-253e-46bf-aa45-1a14f3a6ceb6" providerId="ADAL" clId="{00D7346A-D00E-4A1D-869F-C86D36D9D78D}" dt="2023-08-04T10:22:22.664" v="1" actId="11529"/>
          <ac:spMkLst>
            <pc:docMk/>
            <pc:sldMk cId="116669129" sldId="257"/>
            <ac:spMk id="21" creationId="{106C648A-0995-23C0-BB72-529941262F23}"/>
          </ac:spMkLst>
        </pc:spChg>
        <pc:spChg chg="add">
          <ac:chgData name="Naqvi, Sadaf" userId="f5e58198-253e-46bf-aa45-1a14f3a6ceb6" providerId="ADAL" clId="{00D7346A-D00E-4A1D-869F-C86D36D9D78D}" dt="2023-08-04T10:23:20.206" v="2" actId="11529"/>
          <ac:spMkLst>
            <pc:docMk/>
            <pc:sldMk cId="116669129" sldId="257"/>
            <ac:spMk id="22" creationId="{DA9A1EAA-9200-DCC8-0CAC-EB3C5B934038}"/>
          </ac:spMkLst>
        </pc:spChg>
        <pc:spChg chg="add mod">
          <ac:chgData name="Naqvi, Sadaf" userId="f5e58198-253e-46bf-aa45-1a14f3a6ceb6" providerId="ADAL" clId="{00D7346A-D00E-4A1D-869F-C86D36D9D78D}" dt="2023-08-04T10:23:51.757" v="6" actId="14100"/>
          <ac:spMkLst>
            <pc:docMk/>
            <pc:sldMk cId="116669129" sldId="257"/>
            <ac:spMk id="23" creationId="{A7AB9C71-3C68-31C6-BB61-E1F89052DC4F}"/>
          </ac:spMkLst>
        </pc:spChg>
        <pc:spChg chg="add mod">
          <ac:chgData name="Naqvi, Sadaf" userId="f5e58198-253e-46bf-aa45-1a14f3a6ceb6" providerId="ADAL" clId="{00D7346A-D00E-4A1D-869F-C86D36D9D78D}" dt="2023-08-04T10:24:11.200" v="9" actId="1076"/>
          <ac:spMkLst>
            <pc:docMk/>
            <pc:sldMk cId="116669129" sldId="257"/>
            <ac:spMk id="24" creationId="{0D4458FA-D14B-291D-503E-61B48BA31A41}"/>
          </ac:spMkLst>
        </pc:spChg>
        <pc:spChg chg="add mod">
          <ac:chgData name="Naqvi, Sadaf" userId="f5e58198-253e-46bf-aa45-1a14f3a6ceb6" providerId="ADAL" clId="{00D7346A-D00E-4A1D-869F-C86D36D9D78D}" dt="2023-08-04T10:24:18.300" v="11" actId="1076"/>
          <ac:spMkLst>
            <pc:docMk/>
            <pc:sldMk cId="116669129" sldId="257"/>
            <ac:spMk id="25" creationId="{CA3920AA-CBC0-78C4-51D4-FC0B7F3188BF}"/>
          </ac:spMkLst>
        </pc:spChg>
        <pc:spChg chg="add mod">
          <ac:chgData name="Naqvi, Sadaf" userId="f5e58198-253e-46bf-aa45-1a14f3a6ceb6" providerId="ADAL" clId="{00D7346A-D00E-4A1D-869F-C86D36D9D78D}" dt="2023-08-04T10:24:28.248" v="13" actId="1076"/>
          <ac:spMkLst>
            <pc:docMk/>
            <pc:sldMk cId="116669129" sldId="257"/>
            <ac:spMk id="26" creationId="{26427D30-5D5F-DE3D-CB11-C87788705F23}"/>
          </ac:spMkLst>
        </pc:spChg>
        <pc:spChg chg="add mod">
          <ac:chgData name="Naqvi, Sadaf" userId="f5e58198-253e-46bf-aa45-1a14f3a6ceb6" providerId="ADAL" clId="{00D7346A-D00E-4A1D-869F-C86D36D9D78D}" dt="2023-08-04T10:26:43.827" v="34" actId="1076"/>
          <ac:spMkLst>
            <pc:docMk/>
            <pc:sldMk cId="116669129" sldId="257"/>
            <ac:spMk id="27" creationId="{7C8B8F3D-54B9-8E57-9BD2-4D31BCAB083C}"/>
          </ac:spMkLst>
        </pc:spChg>
        <pc:spChg chg="add mod">
          <ac:chgData name="Naqvi, Sadaf" userId="f5e58198-253e-46bf-aa45-1a14f3a6ceb6" providerId="ADAL" clId="{00D7346A-D00E-4A1D-869F-C86D36D9D78D}" dt="2023-08-04T10:24:55.569" v="27" actId="207"/>
          <ac:spMkLst>
            <pc:docMk/>
            <pc:sldMk cId="116669129" sldId="257"/>
            <ac:spMk id="28" creationId="{446740FA-F3A6-E751-DB3F-0342DB8BEA1D}"/>
          </ac:spMkLst>
        </pc:spChg>
        <pc:spChg chg="add mod">
          <ac:chgData name="Naqvi, Sadaf" userId="f5e58198-253e-46bf-aa45-1a14f3a6ceb6" providerId="ADAL" clId="{00D7346A-D00E-4A1D-869F-C86D36D9D78D}" dt="2023-08-04T10:26:21.549" v="31" actId="20577"/>
          <ac:spMkLst>
            <pc:docMk/>
            <pc:sldMk cId="116669129" sldId="257"/>
            <ac:spMk id="29" creationId="{D78812E7-F834-F420-BC6C-161D4B86D35D}"/>
          </ac:spMkLst>
        </pc:spChg>
        <pc:spChg chg="add mod">
          <ac:chgData name="Naqvi, Sadaf" userId="f5e58198-253e-46bf-aa45-1a14f3a6ceb6" providerId="ADAL" clId="{00D7346A-D00E-4A1D-869F-C86D36D9D78D}" dt="2023-08-04T10:26:53.999" v="39" actId="20577"/>
          <ac:spMkLst>
            <pc:docMk/>
            <pc:sldMk cId="116669129" sldId="257"/>
            <ac:spMk id="30" creationId="{5FEAADAB-772D-1834-1B0B-2AC6F16745CF}"/>
          </ac:spMkLst>
        </pc:spChg>
        <pc:spChg chg="add mod">
          <ac:chgData name="Naqvi, Sadaf" userId="f5e58198-253e-46bf-aa45-1a14f3a6ceb6" providerId="ADAL" clId="{00D7346A-D00E-4A1D-869F-C86D36D9D78D}" dt="2023-08-04T10:27:58.955" v="48" actId="1076"/>
          <ac:spMkLst>
            <pc:docMk/>
            <pc:sldMk cId="116669129" sldId="257"/>
            <ac:spMk id="36" creationId="{A6348809-FF0D-A0B3-0833-424FCF539EBC}"/>
          </ac:spMkLst>
        </pc:spChg>
        <pc:spChg chg="add mod">
          <ac:chgData name="Naqvi, Sadaf" userId="f5e58198-253e-46bf-aa45-1a14f3a6ceb6" providerId="ADAL" clId="{00D7346A-D00E-4A1D-869F-C86D36D9D78D}" dt="2023-08-04T10:28:19.281" v="53" actId="20577"/>
          <ac:spMkLst>
            <pc:docMk/>
            <pc:sldMk cId="116669129" sldId="257"/>
            <ac:spMk id="37" creationId="{6BDC7DF6-2461-281D-2362-626EA71F5DF0}"/>
          </ac:spMkLst>
        </pc:spChg>
        <pc:spChg chg="add del mod">
          <ac:chgData name="Naqvi, Sadaf" userId="f5e58198-253e-46bf-aa45-1a14f3a6ceb6" providerId="ADAL" clId="{00D7346A-D00E-4A1D-869F-C86D36D9D78D}" dt="2023-08-04T10:29:01.953" v="69" actId="478"/>
          <ac:spMkLst>
            <pc:docMk/>
            <pc:sldMk cId="116669129" sldId="257"/>
            <ac:spMk id="38" creationId="{8D0E7EC7-64D7-D8B0-969D-E5A7EB9C0229}"/>
          </ac:spMkLst>
        </pc:spChg>
        <pc:cxnChg chg="add del mod">
          <ac:chgData name="Naqvi, Sadaf" userId="f5e58198-253e-46bf-aa45-1a14f3a6ceb6" providerId="ADAL" clId="{00D7346A-D00E-4A1D-869F-C86D36D9D78D}" dt="2023-08-04T10:27:29.591" v="43" actId="11529"/>
          <ac:cxnSpMkLst>
            <pc:docMk/>
            <pc:sldMk cId="116669129" sldId="257"/>
            <ac:cxnSpMk id="32" creationId="{5588B9F1-463C-7AF3-91D8-5E455A1D2C45}"/>
          </ac:cxnSpMkLst>
        </pc:cxnChg>
        <pc:cxnChg chg="add">
          <ac:chgData name="Naqvi, Sadaf" userId="f5e58198-253e-46bf-aa45-1a14f3a6ceb6" providerId="ADAL" clId="{00D7346A-D00E-4A1D-869F-C86D36D9D78D}" dt="2023-08-04T10:27:36.202" v="44" actId="11529"/>
          <ac:cxnSpMkLst>
            <pc:docMk/>
            <pc:sldMk cId="116669129" sldId="257"/>
            <ac:cxnSpMk id="34" creationId="{3E0A906A-FAE3-3BB3-A905-DB0F7457BF5C}"/>
          </ac:cxnSpMkLst>
        </pc:cxnChg>
        <pc:cxnChg chg="add mod">
          <ac:chgData name="Naqvi, Sadaf" userId="f5e58198-253e-46bf-aa45-1a14f3a6ceb6" providerId="ADAL" clId="{00D7346A-D00E-4A1D-869F-C86D36D9D78D}" dt="2023-08-04T10:27:46.181" v="46" actId="1076"/>
          <ac:cxnSpMkLst>
            <pc:docMk/>
            <pc:sldMk cId="116669129" sldId="257"/>
            <ac:cxnSpMk id="35" creationId="{60A24B5E-7C99-743B-3DD1-3A7DB69A7B5A}"/>
          </ac:cxnSpMkLst>
        </pc:cxnChg>
      </pc:sldChg>
    </pc:docChg>
  </pc:docChgLst>
  <pc:docChgLst>
    <pc:chgData name="Sadaf Naqvi" userId="8f91277e-8741-4995-819e-50b4e5326a9f" providerId="ADAL" clId="{63BF868D-224E-4873-BE58-D888B46218D2}"/>
    <pc:docChg chg="undo custSel modSld">
      <pc:chgData name="Sadaf Naqvi" userId="8f91277e-8741-4995-819e-50b4e5326a9f" providerId="ADAL" clId="{63BF868D-224E-4873-BE58-D888B46218D2}" dt="2024-11-14T09:28:13.454" v="50" actId="113"/>
      <pc:docMkLst>
        <pc:docMk/>
      </pc:docMkLst>
      <pc:sldChg chg="addSp delSp modSp mod">
        <pc:chgData name="Sadaf Naqvi" userId="8f91277e-8741-4995-819e-50b4e5326a9f" providerId="ADAL" clId="{63BF868D-224E-4873-BE58-D888B46218D2}" dt="2024-11-14T09:28:13.454" v="50" actId="113"/>
        <pc:sldMkLst>
          <pc:docMk/>
          <pc:sldMk cId="116669129" sldId="257"/>
        </pc:sldMkLst>
        <pc:spChg chg="add mod">
          <ac:chgData name="Sadaf Naqvi" userId="8f91277e-8741-4995-819e-50b4e5326a9f" providerId="ADAL" clId="{63BF868D-224E-4873-BE58-D888B46218D2}" dt="2024-11-14T09:28:13.454" v="50" actId="113"/>
          <ac:spMkLst>
            <pc:docMk/>
            <pc:sldMk cId="116669129" sldId="257"/>
            <ac:spMk id="3" creationId="{A2603FA1-6FC4-C0FE-7595-FEAC7CF66488}"/>
          </ac:spMkLst>
        </pc:spChg>
        <pc:spChg chg="mod topLvl">
          <ac:chgData name="Sadaf Naqvi" userId="8f91277e-8741-4995-819e-50b4e5326a9f" providerId="ADAL" clId="{63BF868D-224E-4873-BE58-D888B46218D2}" dt="2024-11-14T09:27:38.349" v="25" actId="165"/>
          <ac:spMkLst>
            <pc:docMk/>
            <pc:sldMk cId="116669129" sldId="257"/>
            <ac:spMk id="4" creationId="{3F0B0651-2219-FC9B-25A4-35DBEEB8E073}"/>
          </ac:spMkLst>
        </pc:spChg>
        <pc:spChg chg="mod topLvl">
          <ac:chgData name="Sadaf Naqvi" userId="8f91277e-8741-4995-819e-50b4e5326a9f" providerId="ADAL" clId="{63BF868D-224E-4873-BE58-D888B46218D2}" dt="2024-11-14T09:27:38.349" v="25" actId="165"/>
          <ac:spMkLst>
            <pc:docMk/>
            <pc:sldMk cId="116669129" sldId="257"/>
            <ac:spMk id="5" creationId="{1313B7E7-ED28-6892-289A-E4333ACAC4B0}"/>
          </ac:spMkLst>
        </pc:spChg>
        <pc:spChg chg="mod topLvl">
          <ac:chgData name="Sadaf Naqvi" userId="8f91277e-8741-4995-819e-50b4e5326a9f" providerId="ADAL" clId="{63BF868D-224E-4873-BE58-D888B46218D2}" dt="2024-11-14T09:27:38.349" v="25" actId="165"/>
          <ac:spMkLst>
            <pc:docMk/>
            <pc:sldMk cId="116669129" sldId="257"/>
            <ac:spMk id="6" creationId="{327DCB44-1F63-25D1-7972-3B90A8CF0A73}"/>
          </ac:spMkLst>
        </pc:spChg>
        <pc:spChg chg="mod topLvl">
          <ac:chgData name="Sadaf Naqvi" userId="8f91277e-8741-4995-819e-50b4e5326a9f" providerId="ADAL" clId="{63BF868D-224E-4873-BE58-D888B46218D2}" dt="2024-11-14T09:27:38.349" v="25" actId="165"/>
          <ac:spMkLst>
            <pc:docMk/>
            <pc:sldMk cId="116669129" sldId="257"/>
            <ac:spMk id="7" creationId="{AC066418-F89D-CB21-AE10-CE698159BDA8}"/>
          </ac:spMkLst>
        </pc:spChg>
        <pc:spChg chg="mod topLvl">
          <ac:chgData name="Sadaf Naqvi" userId="8f91277e-8741-4995-819e-50b4e5326a9f" providerId="ADAL" clId="{63BF868D-224E-4873-BE58-D888B46218D2}" dt="2024-11-14T09:27:38.349" v="25" actId="165"/>
          <ac:spMkLst>
            <pc:docMk/>
            <pc:sldMk cId="116669129" sldId="257"/>
            <ac:spMk id="14" creationId="{B74961BF-5ECE-8064-A8FC-A40A974A54CA}"/>
          </ac:spMkLst>
        </pc:spChg>
        <pc:spChg chg="mod topLvl">
          <ac:chgData name="Sadaf Naqvi" userId="8f91277e-8741-4995-819e-50b4e5326a9f" providerId="ADAL" clId="{63BF868D-224E-4873-BE58-D888B46218D2}" dt="2024-11-14T09:27:38.349" v="25" actId="165"/>
          <ac:spMkLst>
            <pc:docMk/>
            <pc:sldMk cId="116669129" sldId="257"/>
            <ac:spMk id="15" creationId="{430317DA-9FFE-8845-2760-7653A840672F}"/>
          </ac:spMkLst>
        </pc:spChg>
        <pc:spChg chg="mod topLvl">
          <ac:chgData name="Sadaf Naqvi" userId="8f91277e-8741-4995-819e-50b4e5326a9f" providerId="ADAL" clId="{63BF868D-224E-4873-BE58-D888B46218D2}" dt="2024-11-14T09:27:38.349" v="25" actId="165"/>
          <ac:spMkLst>
            <pc:docMk/>
            <pc:sldMk cId="116669129" sldId="257"/>
            <ac:spMk id="16" creationId="{B66692A5-DB4A-559E-7530-CC7DB56D7548}"/>
          </ac:spMkLst>
        </pc:spChg>
        <pc:spChg chg="mod topLvl">
          <ac:chgData name="Sadaf Naqvi" userId="8f91277e-8741-4995-819e-50b4e5326a9f" providerId="ADAL" clId="{63BF868D-224E-4873-BE58-D888B46218D2}" dt="2024-11-14T09:27:38.349" v="25" actId="165"/>
          <ac:spMkLst>
            <pc:docMk/>
            <pc:sldMk cId="116669129" sldId="257"/>
            <ac:spMk id="20" creationId="{E9EE8D32-DECC-CF5C-8F55-3E2F8E922067}"/>
          </ac:spMkLst>
        </pc:spChg>
        <pc:spChg chg="mod topLvl">
          <ac:chgData name="Sadaf Naqvi" userId="8f91277e-8741-4995-819e-50b4e5326a9f" providerId="ADAL" clId="{63BF868D-224E-4873-BE58-D888B46218D2}" dt="2024-11-14T09:27:38.349" v="25" actId="165"/>
          <ac:spMkLst>
            <pc:docMk/>
            <pc:sldMk cId="116669129" sldId="257"/>
            <ac:spMk id="22" creationId="{DA9A1EAA-9200-DCC8-0CAC-EB3C5B934038}"/>
          </ac:spMkLst>
        </pc:spChg>
        <pc:spChg chg="mod topLvl">
          <ac:chgData name="Sadaf Naqvi" userId="8f91277e-8741-4995-819e-50b4e5326a9f" providerId="ADAL" clId="{63BF868D-224E-4873-BE58-D888B46218D2}" dt="2024-11-14T09:27:38.349" v="25" actId="165"/>
          <ac:spMkLst>
            <pc:docMk/>
            <pc:sldMk cId="116669129" sldId="257"/>
            <ac:spMk id="23" creationId="{A7AB9C71-3C68-31C6-BB61-E1F89052DC4F}"/>
          </ac:spMkLst>
        </pc:spChg>
        <pc:spChg chg="mod topLvl">
          <ac:chgData name="Sadaf Naqvi" userId="8f91277e-8741-4995-819e-50b4e5326a9f" providerId="ADAL" clId="{63BF868D-224E-4873-BE58-D888B46218D2}" dt="2024-11-14T09:27:38.349" v="25" actId="165"/>
          <ac:spMkLst>
            <pc:docMk/>
            <pc:sldMk cId="116669129" sldId="257"/>
            <ac:spMk id="24" creationId="{0D4458FA-D14B-291D-503E-61B48BA31A41}"/>
          </ac:spMkLst>
        </pc:spChg>
        <pc:spChg chg="mod topLvl">
          <ac:chgData name="Sadaf Naqvi" userId="8f91277e-8741-4995-819e-50b4e5326a9f" providerId="ADAL" clId="{63BF868D-224E-4873-BE58-D888B46218D2}" dt="2024-11-14T09:27:38.349" v="25" actId="165"/>
          <ac:spMkLst>
            <pc:docMk/>
            <pc:sldMk cId="116669129" sldId="257"/>
            <ac:spMk id="25" creationId="{CA3920AA-CBC0-78C4-51D4-FC0B7F3188BF}"/>
          </ac:spMkLst>
        </pc:spChg>
        <pc:spChg chg="mod topLvl">
          <ac:chgData name="Sadaf Naqvi" userId="8f91277e-8741-4995-819e-50b4e5326a9f" providerId="ADAL" clId="{63BF868D-224E-4873-BE58-D888B46218D2}" dt="2024-11-14T09:27:38.349" v="25" actId="165"/>
          <ac:spMkLst>
            <pc:docMk/>
            <pc:sldMk cId="116669129" sldId="257"/>
            <ac:spMk id="26" creationId="{26427D30-5D5F-DE3D-CB11-C87788705F23}"/>
          </ac:spMkLst>
        </pc:spChg>
        <pc:spChg chg="mod topLvl">
          <ac:chgData name="Sadaf Naqvi" userId="8f91277e-8741-4995-819e-50b4e5326a9f" providerId="ADAL" clId="{63BF868D-224E-4873-BE58-D888B46218D2}" dt="2024-11-14T09:27:38.349" v="25" actId="165"/>
          <ac:spMkLst>
            <pc:docMk/>
            <pc:sldMk cId="116669129" sldId="257"/>
            <ac:spMk id="27" creationId="{7C8B8F3D-54B9-8E57-9BD2-4D31BCAB083C}"/>
          </ac:spMkLst>
        </pc:spChg>
        <pc:spChg chg="mod topLvl">
          <ac:chgData name="Sadaf Naqvi" userId="8f91277e-8741-4995-819e-50b4e5326a9f" providerId="ADAL" clId="{63BF868D-224E-4873-BE58-D888B46218D2}" dt="2024-11-14T09:27:38.349" v="25" actId="165"/>
          <ac:spMkLst>
            <pc:docMk/>
            <pc:sldMk cId="116669129" sldId="257"/>
            <ac:spMk id="28" creationId="{446740FA-F3A6-E751-DB3F-0342DB8BEA1D}"/>
          </ac:spMkLst>
        </pc:spChg>
        <pc:spChg chg="mod topLvl">
          <ac:chgData name="Sadaf Naqvi" userId="8f91277e-8741-4995-819e-50b4e5326a9f" providerId="ADAL" clId="{63BF868D-224E-4873-BE58-D888B46218D2}" dt="2024-11-14T09:27:38.349" v="25" actId="165"/>
          <ac:spMkLst>
            <pc:docMk/>
            <pc:sldMk cId="116669129" sldId="257"/>
            <ac:spMk id="29" creationId="{D78812E7-F834-F420-BC6C-161D4B86D35D}"/>
          </ac:spMkLst>
        </pc:spChg>
        <pc:spChg chg="mod topLvl">
          <ac:chgData name="Sadaf Naqvi" userId="8f91277e-8741-4995-819e-50b4e5326a9f" providerId="ADAL" clId="{63BF868D-224E-4873-BE58-D888B46218D2}" dt="2024-11-14T09:27:38.349" v="25" actId="165"/>
          <ac:spMkLst>
            <pc:docMk/>
            <pc:sldMk cId="116669129" sldId="257"/>
            <ac:spMk id="30" creationId="{5FEAADAB-772D-1834-1B0B-2AC6F16745CF}"/>
          </ac:spMkLst>
        </pc:spChg>
        <pc:spChg chg="mod topLvl">
          <ac:chgData name="Sadaf Naqvi" userId="8f91277e-8741-4995-819e-50b4e5326a9f" providerId="ADAL" clId="{63BF868D-224E-4873-BE58-D888B46218D2}" dt="2024-11-14T09:27:38.349" v="25" actId="165"/>
          <ac:spMkLst>
            <pc:docMk/>
            <pc:sldMk cId="116669129" sldId="257"/>
            <ac:spMk id="36" creationId="{A6348809-FF0D-A0B3-0833-424FCF539EBC}"/>
          </ac:spMkLst>
        </pc:spChg>
        <pc:spChg chg="mod topLvl">
          <ac:chgData name="Sadaf Naqvi" userId="8f91277e-8741-4995-819e-50b4e5326a9f" providerId="ADAL" clId="{63BF868D-224E-4873-BE58-D888B46218D2}" dt="2024-11-14T09:27:38.349" v="25" actId="165"/>
          <ac:spMkLst>
            <pc:docMk/>
            <pc:sldMk cId="116669129" sldId="257"/>
            <ac:spMk id="37" creationId="{6BDC7DF6-2461-281D-2362-626EA71F5DF0}"/>
          </ac:spMkLst>
        </pc:spChg>
        <pc:grpChg chg="add del mod">
          <ac:chgData name="Sadaf Naqvi" userId="8f91277e-8741-4995-819e-50b4e5326a9f" providerId="ADAL" clId="{63BF868D-224E-4873-BE58-D888B46218D2}" dt="2024-11-14T09:27:38.349" v="25" actId="165"/>
          <ac:grpSpMkLst>
            <pc:docMk/>
            <pc:sldMk cId="116669129" sldId="257"/>
            <ac:grpSpMk id="2" creationId="{DFE52CCA-A859-1DE6-0EF0-F21E31DD7A5C}"/>
          </ac:grpSpMkLst>
        </pc:grpChg>
        <pc:picChg chg="mod topLvl">
          <ac:chgData name="Sadaf Naqvi" userId="8f91277e-8741-4995-819e-50b4e5326a9f" providerId="ADAL" clId="{63BF868D-224E-4873-BE58-D888B46218D2}" dt="2024-11-14T09:27:38.349" v="25" actId="165"/>
          <ac:picMkLst>
            <pc:docMk/>
            <pc:sldMk cId="116669129" sldId="257"/>
            <ac:picMk id="9" creationId="{865C8B72-A2B2-A6C0-A450-ED30D5A205FA}"/>
          </ac:picMkLst>
        </pc:picChg>
        <pc:picChg chg="mod topLvl">
          <ac:chgData name="Sadaf Naqvi" userId="8f91277e-8741-4995-819e-50b4e5326a9f" providerId="ADAL" clId="{63BF868D-224E-4873-BE58-D888B46218D2}" dt="2024-11-14T09:27:38.349" v="25" actId="165"/>
          <ac:picMkLst>
            <pc:docMk/>
            <pc:sldMk cId="116669129" sldId="257"/>
            <ac:picMk id="10" creationId="{50BC5DAA-CF6C-7010-FB61-5111CEE7D1EB}"/>
          </ac:picMkLst>
        </pc:picChg>
        <pc:picChg chg="mod topLvl">
          <ac:chgData name="Sadaf Naqvi" userId="8f91277e-8741-4995-819e-50b4e5326a9f" providerId="ADAL" clId="{63BF868D-224E-4873-BE58-D888B46218D2}" dt="2024-11-14T09:27:38.349" v="25" actId="165"/>
          <ac:picMkLst>
            <pc:docMk/>
            <pc:sldMk cId="116669129" sldId="257"/>
            <ac:picMk id="11" creationId="{A34D1BD5-3BC2-1559-67E2-830966FD51D9}"/>
          </ac:picMkLst>
        </pc:picChg>
        <pc:picChg chg="mod topLvl">
          <ac:chgData name="Sadaf Naqvi" userId="8f91277e-8741-4995-819e-50b4e5326a9f" providerId="ADAL" clId="{63BF868D-224E-4873-BE58-D888B46218D2}" dt="2024-11-14T09:27:38.349" v="25" actId="165"/>
          <ac:picMkLst>
            <pc:docMk/>
            <pc:sldMk cId="116669129" sldId="257"/>
            <ac:picMk id="12" creationId="{73253138-BC10-E204-83FA-AD91AF6CBFA0}"/>
          </ac:picMkLst>
        </pc:picChg>
        <pc:cxnChg chg="mod topLvl">
          <ac:chgData name="Sadaf Naqvi" userId="8f91277e-8741-4995-819e-50b4e5326a9f" providerId="ADAL" clId="{63BF868D-224E-4873-BE58-D888B46218D2}" dt="2024-11-14T09:27:38.349" v="25" actId="165"/>
          <ac:cxnSpMkLst>
            <pc:docMk/>
            <pc:sldMk cId="116669129" sldId="257"/>
            <ac:cxnSpMk id="18" creationId="{3DF9EE78-F02A-E0F9-FA98-305F34837232}"/>
          </ac:cxnSpMkLst>
        </pc:cxnChg>
        <pc:cxnChg chg="mod topLvl">
          <ac:chgData name="Sadaf Naqvi" userId="8f91277e-8741-4995-819e-50b4e5326a9f" providerId="ADAL" clId="{63BF868D-224E-4873-BE58-D888B46218D2}" dt="2024-11-14T09:27:38.349" v="25" actId="165"/>
          <ac:cxnSpMkLst>
            <pc:docMk/>
            <pc:sldMk cId="116669129" sldId="257"/>
            <ac:cxnSpMk id="19" creationId="{53AB0DFB-60D0-8F93-CF06-A1B123948B8D}"/>
          </ac:cxnSpMkLst>
        </pc:cxnChg>
        <pc:cxnChg chg="mod topLvl">
          <ac:chgData name="Sadaf Naqvi" userId="8f91277e-8741-4995-819e-50b4e5326a9f" providerId="ADAL" clId="{63BF868D-224E-4873-BE58-D888B46218D2}" dt="2024-11-14T09:27:38.349" v="25" actId="165"/>
          <ac:cxnSpMkLst>
            <pc:docMk/>
            <pc:sldMk cId="116669129" sldId="257"/>
            <ac:cxnSpMk id="34" creationId="{3E0A906A-FAE3-3BB3-A905-DB0F7457BF5C}"/>
          </ac:cxnSpMkLst>
        </pc:cxnChg>
        <pc:cxnChg chg="mod topLvl">
          <ac:chgData name="Sadaf Naqvi" userId="8f91277e-8741-4995-819e-50b4e5326a9f" providerId="ADAL" clId="{63BF868D-224E-4873-BE58-D888B46218D2}" dt="2024-11-14T09:27:38.349" v="25" actId="165"/>
          <ac:cxnSpMkLst>
            <pc:docMk/>
            <pc:sldMk cId="116669129" sldId="257"/>
            <ac:cxnSpMk id="35" creationId="{60A24B5E-7C99-743B-3DD1-3A7DB69A7B5A}"/>
          </ac:cxnSpMkLst>
        </pc:cxnChg>
      </pc:sldChg>
    </pc:docChg>
  </pc:docChgLst>
  <pc:docChgLst>
    <pc:chgData name="Sadaf Naqvi" userId="8f91277e-8741-4995-819e-50b4e5326a9f" providerId="ADAL" clId="{335EC5F1-4726-48B0-B01E-9D58D59ED537}"/>
    <pc:docChg chg="delSld">
      <pc:chgData name="Sadaf Naqvi" userId="8f91277e-8741-4995-819e-50b4e5326a9f" providerId="ADAL" clId="{335EC5F1-4726-48B0-B01E-9D58D59ED537}" dt="2024-11-14T09:22:55.999" v="0" actId="2696"/>
      <pc:docMkLst>
        <pc:docMk/>
      </pc:docMkLst>
      <pc:sldChg chg="del">
        <pc:chgData name="Sadaf Naqvi" userId="8f91277e-8741-4995-819e-50b4e5326a9f" providerId="ADAL" clId="{335EC5F1-4726-48B0-B01E-9D58D59ED537}" dt="2024-11-14T09:22:55.999" v="0" actId="2696"/>
        <pc:sldMkLst>
          <pc:docMk/>
          <pc:sldMk cId="1249063990" sldId="256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0489FC-924E-FBE7-EBFB-74E8649CB5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28DD963-A82B-145E-5799-F537E567A6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B0C139-CE9E-7E27-9C99-3CA4511AE2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BAC84-8A33-4485-96B6-16796E03BAC4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37E011-3946-E118-AD74-DC5ECF82AE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A263DF-9AF9-1AA8-321C-BA35EE5343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98347-FF6E-40B5-904B-D4BCA4083B1C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9846439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7E0B0B-216C-3846-2AC7-DEB406CFD5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4DD0F9-C60D-DEE7-B5D4-25713C8245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6D761E-395D-9587-E370-CAA08EB75E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BAC84-8A33-4485-96B6-16796E03BAC4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C6177C-AEC1-716C-72C9-BC133B4172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9386E2-3D64-7400-7C9C-68BC43AC7D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98347-FF6E-40B5-904B-D4BCA4083B1C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7305170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7E6F319-63B4-D652-989F-B1785F1F54E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3EAFEEE-AEC5-161B-EE2A-D39E1DC67C7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ED6E3B-6F0D-36B6-126F-F528A018FF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BAC84-8A33-4485-96B6-16796E03BAC4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9A0C09-DA09-FA21-C128-8C4D64B1F4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9D374F-6D67-0220-D99C-C0B5113C15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98347-FF6E-40B5-904B-D4BCA4083B1C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9413917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EFE2B1-FDE4-B33C-D7C0-568C2563E6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972DE6-6002-C3CB-F700-F0328EB64A4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1D9C2E-328D-3EF7-60DE-9BA3228F9A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BAC84-8A33-4485-96B6-16796E03BAC4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9CA938-E226-AD09-524E-6980BEF256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16B879-932F-FAF1-2864-34416BFAF1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98347-FF6E-40B5-904B-D4BCA4083B1C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16301151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336026-0834-FAA2-63C1-3430C20A2D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262339-81ED-1944-18D7-92FF84B8D2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00408D-D457-8BB8-2EC5-ECAECE6254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BAC84-8A33-4485-96B6-16796E03BAC4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847DFD-B80B-3FC1-220D-0712206CD3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B43DC5-2413-C0A4-4AA4-51A0E49060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98347-FF6E-40B5-904B-D4BCA4083B1C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33787606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279894-6A5E-E3DD-A2F0-FFF7D4D79E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71BF7D-3825-903A-1AF0-61571C126E5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504B01F-7D5D-C5A8-7D56-1E6D0B0AEE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E18DA3-32BE-5F16-1AE3-8458D7F5EC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BAC84-8A33-4485-96B6-16796E03BAC4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A618CE9-C835-DE57-75A1-2A88A78A60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959D667-4970-1446-82B8-50375B9C7E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98347-FF6E-40B5-904B-D4BCA4083B1C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5164408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406F34-6B1B-E83C-2F13-0D42F37B78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B1BEA56-0AD7-4079-896F-8E247621D2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D3BF1B-2E36-81A9-9E37-567C28D7AD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2396C8F-A767-92F8-4E32-C82A8DA8309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A133C4C-F3EC-6BA6-2F9F-DFD4071EDE6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9F1DC1E-5B03-0710-1391-991D8B267B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BAC84-8A33-4485-96B6-16796E03BAC4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18EC0FB-A3AF-1A9A-E625-972D661E75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E408428-1B0F-9D05-D749-B098BEDF5B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98347-FF6E-40B5-904B-D4BCA4083B1C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14168962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3FC9D8-F6A4-72FC-4126-7848313263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0AC32FF-AC26-34B2-FF68-AAA568B27D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BAC84-8A33-4485-96B6-16796E03BAC4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57B30B8-BB4D-6BFB-243C-4BB7EF47B4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48139DC-4334-72F1-D04A-42AD75EC62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98347-FF6E-40B5-904B-D4BCA4083B1C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8876294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98426DA-FAAE-B5CC-4A0F-32C1B8CF4B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BAC84-8A33-4485-96B6-16796E03BAC4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BCAD86C-3964-E02E-11E2-B448E876F0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EC1E469-D1AA-FDFD-BB06-88D27EAF69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98347-FF6E-40B5-904B-D4BCA4083B1C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29237378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0678AF-FCE7-E110-1CDF-D0CD18070D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6D37EE-9E4A-18EA-C0EB-E5D596E5465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3644D4D-90A5-1EC5-D329-FF04FE39C6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E81F14-3976-719B-B6D5-702ACEA927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BAC84-8A33-4485-96B6-16796E03BAC4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147663-0C2F-B4BD-C9E5-2A61721777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1287AB-793D-8669-C384-1DFD04AE9A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98347-FF6E-40B5-904B-D4BCA4083B1C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39612315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F4D836-4FC8-F5A1-EBA7-017C400BD3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CBAD31E-75A8-C9EF-14B6-205892F441D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1A03D14-513D-924D-9E8E-6F59C884B5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21E272-5F80-2757-F00C-5F1146DCDC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BAC84-8A33-4485-96B6-16796E03BAC4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E06562-13F5-7C35-5A5A-B07244CC4F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BB2D23-2929-7434-85DA-BCE4A9361A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98347-FF6E-40B5-904B-D4BCA4083B1C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7750718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64169D1-FA4C-EAA8-6A29-BC76338B10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3E2E50F-F48C-E51E-036E-C913732AE4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85D27B-3909-14B2-7306-3CDB1494A37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8BAC84-8A33-4485-96B6-16796E03BAC4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818EC2-AE6E-9872-28A1-57A2A7EFB7A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BA50BC-0088-9530-B4D8-4C5D19D685E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898347-FF6E-40B5-904B-D4BCA4083B1C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1097003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lowchart: Connector 3">
            <a:extLst>
              <a:ext uri="{FF2B5EF4-FFF2-40B4-BE49-F238E27FC236}">
                <a16:creationId xmlns:a16="http://schemas.microsoft.com/office/drawing/2014/main" id="{3F0B0651-2219-FC9B-25A4-35DBEEB8E073}"/>
              </a:ext>
            </a:extLst>
          </p:cNvPr>
          <p:cNvSpPr/>
          <p:nvPr/>
        </p:nvSpPr>
        <p:spPr>
          <a:xfrm>
            <a:off x="1668521" y="1445428"/>
            <a:ext cx="962025" cy="971550"/>
          </a:xfrm>
          <a:prstGeom prst="flowChartConnector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E"/>
          </a:p>
        </p:txBody>
      </p:sp>
      <p:sp>
        <p:nvSpPr>
          <p:cNvPr id="5" name="Flowchart: Connector 4">
            <a:extLst>
              <a:ext uri="{FF2B5EF4-FFF2-40B4-BE49-F238E27FC236}">
                <a16:creationId xmlns:a16="http://schemas.microsoft.com/office/drawing/2014/main" id="{1313B7E7-ED28-6892-289A-E4333ACAC4B0}"/>
              </a:ext>
            </a:extLst>
          </p:cNvPr>
          <p:cNvSpPr/>
          <p:nvPr/>
        </p:nvSpPr>
        <p:spPr>
          <a:xfrm>
            <a:off x="4049216" y="2661669"/>
            <a:ext cx="962025" cy="971550"/>
          </a:xfrm>
          <a:prstGeom prst="flowChartConnector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E"/>
          </a:p>
        </p:txBody>
      </p:sp>
      <p:sp>
        <p:nvSpPr>
          <p:cNvPr id="6" name="Flowchart: Connector 5">
            <a:extLst>
              <a:ext uri="{FF2B5EF4-FFF2-40B4-BE49-F238E27FC236}">
                <a16:creationId xmlns:a16="http://schemas.microsoft.com/office/drawing/2014/main" id="{327DCB44-1F63-25D1-7972-3B90A8CF0A73}"/>
              </a:ext>
            </a:extLst>
          </p:cNvPr>
          <p:cNvSpPr/>
          <p:nvPr/>
        </p:nvSpPr>
        <p:spPr>
          <a:xfrm>
            <a:off x="6255409" y="3866905"/>
            <a:ext cx="962025" cy="971550"/>
          </a:xfrm>
          <a:prstGeom prst="flowChartConnector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E"/>
          </a:p>
        </p:txBody>
      </p:sp>
      <p:sp>
        <p:nvSpPr>
          <p:cNvPr id="7" name="Flowchart: Connector 6">
            <a:extLst>
              <a:ext uri="{FF2B5EF4-FFF2-40B4-BE49-F238E27FC236}">
                <a16:creationId xmlns:a16="http://schemas.microsoft.com/office/drawing/2014/main" id="{AC066418-F89D-CB21-AE10-CE698159BDA8}"/>
              </a:ext>
            </a:extLst>
          </p:cNvPr>
          <p:cNvSpPr/>
          <p:nvPr/>
        </p:nvSpPr>
        <p:spPr>
          <a:xfrm>
            <a:off x="9556378" y="2645671"/>
            <a:ext cx="962025" cy="971550"/>
          </a:xfrm>
          <a:prstGeom prst="flowChartConnector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E" dirty="0"/>
          </a:p>
        </p:txBody>
      </p:sp>
      <p:pic>
        <p:nvPicPr>
          <p:cNvPr id="9" name="Graphic 8" descr="Walk with solid fill">
            <a:extLst>
              <a:ext uri="{FF2B5EF4-FFF2-40B4-BE49-F238E27FC236}">
                <a16:creationId xmlns:a16="http://schemas.microsoft.com/office/drawing/2014/main" id="{865C8B72-A2B2-A6C0-A450-ED30D5A205F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716146" y="1474003"/>
            <a:ext cx="914400" cy="914400"/>
          </a:xfrm>
          <a:prstGeom prst="rect">
            <a:avLst/>
          </a:prstGeom>
        </p:spPr>
      </p:pic>
      <p:pic>
        <p:nvPicPr>
          <p:cNvPr id="10" name="Graphic 9" descr="Walk with solid fill">
            <a:extLst>
              <a:ext uri="{FF2B5EF4-FFF2-40B4-BE49-F238E27FC236}">
                <a16:creationId xmlns:a16="http://schemas.microsoft.com/office/drawing/2014/main" id="{50BC5DAA-CF6C-7010-FB61-5111CEE7D1E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4073028" y="2690244"/>
            <a:ext cx="914400" cy="914400"/>
          </a:xfrm>
          <a:prstGeom prst="rect">
            <a:avLst/>
          </a:prstGeom>
        </p:spPr>
      </p:pic>
      <p:pic>
        <p:nvPicPr>
          <p:cNvPr id="11" name="Graphic 10" descr="Walk with solid fill">
            <a:extLst>
              <a:ext uri="{FF2B5EF4-FFF2-40B4-BE49-F238E27FC236}">
                <a16:creationId xmlns:a16="http://schemas.microsoft.com/office/drawing/2014/main" id="{A34D1BD5-3BC2-1559-67E2-830966FD51D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6255409" y="3895480"/>
            <a:ext cx="914400" cy="914400"/>
          </a:xfrm>
          <a:prstGeom prst="rect">
            <a:avLst/>
          </a:prstGeom>
        </p:spPr>
      </p:pic>
      <p:pic>
        <p:nvPicPr>
          <p:cNvPr id="12" name="Graphic 11" descr="Walk with solid fill">
            <a:extLst>
              <a:ext uri="{FF2B5EF4-FFF2-40B4-BE49-F238E27FC236}">
                <a16:creationId xmlns:a16="http://schemas.microsoft.com/office/drawing/2014/main" id="{73253138-BC10-E204-83FA-AD91AF6CBFA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9604003" y="2645671"/>
            <a:ext cx="914400" cy="91440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B74961BF-5ECE-8064-A8FC-A40A974A54CA}"/>
              </a:ext>
            </a:extLst>
          </p:cNvPr>
          <p:cNvSpPr txBox="1"/>
          <p:nvPr/>
        </p:nvSpPr>
        <p:spPr>
          <a:xfrm>
            <a:off x="1467663" y="2477003"/>
            <a:ext cx="1829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heck in to Nurse</a:t>
            </a:r>
            <a:endParaRPr lang="en-AE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30317DA-9FFE-8845-2760-7653A840672F}"/>
              </a:ext>
            </a:extLst>
          </p:cNvPr>
          <p:cNvSpPr txBox="1"/>
          <p:nvPr/>
        </p:nvSpPr>
        <p:spPr>
          <a:xfrm>
            <a:off x="3615458" y="3799490"/>
            <a:ext cx="1903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urse to Physician</a:t>
            </a:r>
            <a:endParaRPr lang="en-AE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66692A5-DB4A-559E-7530-CC7DB56D7548}"/>
              </a:ext>
            </a:extLst>
          </p:cNvPr>
          <p:cNvSpPr txBox="1"/>
          <p:nvPr/>
        </p:nvSpPr>
        <p:spPr>
          <a:xfrm>
            <a:off x="5925131" y="4990577"/>
            <a:ext cx="22265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hysician to Checkout</a:t>
            </a:r>
            <a:endParaRPr lang="en-AE" dirty="0"/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3DF9EE78-F02A-E0F9-FA98-305F34837232}"/>
              </a:ext>
            </a:extLst>
          </p:cNvPr>
          <p:cNvCxnSpPr/>
          <p:nvPr/>
        </p:nvCxnSpPr>
        <p:spPr>
          <a:xfrm>
            <a:off x="10037390" y="1163469"/>
            <a:ext cx="0" cy="133219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53AB0DFB-60D0-8F93-CF06-A1B123948B8D}"/>
              </a:ext>
            </a:extLst>
          </p:cNvPr>
          <p:cNvCxnSpPr/>
          <p:nvPr/>
        </p:nvCxnSpPr>
        <p:spPr>
          <a:xfrm>
            <a:off x="10061203" y="3686581"/>
            <a:ext cx="0" cy="133219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E9EE8D32-DECC-CF5C-8F55-3E2F8E922067}"/>
              </a:ext>
            </a:extLst>
          </p:cNvPr>
          <p:cNvSpPr txBox="1"/>
          <p:nvPr/>
        </p:nvSpPr>
        <p:spPr>
          <a:xfrm rot="16200000">
            <a:off x="9586887" y="3181013"/>
            <a:ext cx="22711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heck In to Check out </a:t>
            </a:r>
            <a:endParaRPr lang="en-AE" dirty="0"/>
          </a:p>
        </p:txBody>
      </p:sp>
      <p:sp>
        <p:nvSpPr>
          <p:cNvPr id="22" name="Arc 21">
            <a:extLst>
              <a:ext uri="{FF2B5EF4-FFF2-40B4-BE49-F238E27FC236}">
                <a16:creationId xmlns:a16="http://schemas.microsoft.com/office/drawing/2014/main" id="{DA9A1EAA-9200-DCC8-0CAC-EB3C5B934038}"/>
              </a:ext>
            </a:extLst>
          </p:cNvPr>
          <p:cNvSpPr/>
          <p:nvPr/>
        </p:nvSpPr>
        <p:spPr>
          <a:xfrm>
            <a:off x="2106855" y="3018902"/>
            <a:ext cx="962023" cy="1216241"/>
          </a:xfrm>
          <a:prstGeom prst="arc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E"/>
          </a:p>
        </p:txBody>
      </p:sp>
      <p:sp>
        <p:nvSpPr>
          <p:cNvPr id="23" name="Isosceles Triangle 22">
            <a:extLst>
              <a:ext uri="{FF2B5EF4-FFF2-40B4-BE49-F238E27FC236}">
                <a16:creationId xmlns:a16="http://schemas.microsoft.com/office/drawing/2014/main" id="{A7AB9C71-3C68-31C6-BB61-E1F89052DC4F}"/>
              </a:ext>
            </a:extLst>
          </p:cNvPr>
          <p:cNvSpPr/>
          <p:nvPr/>
        </p:nvSpPr>
        <p:spPr>
          <a:xfrm rot="10800000">
            <a:off x="2984716" y="3633219"/>
            <a:ext cx="154155" cy="164326"/>
          </a:xfrm>
          <a:prstGeom prst="triangl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E"/>
          </a:p>
        </p:txBody>
      </p:sp>
      <p:sp>
        <p:nvSpPr>
          <p:cNvPr id="24" name="Arc 23">
            <a:extLst>
              <a:ext uri="{FF2B5EF4-FFF2-40B4-BE49-F238E27FC236}">
                <a16:creationId xmlns:a16="http://schemas.microsoft.com/office/drawing/2014/main" id="{0D4458FA-D14B-291D-503E-61B48BA31A41}"/>
              </a:ext>
            </a:extLst>
          </p:cNvPr>
          <p:cNvSpPr/>
          <p:nvPr/>
        </p:nvSpPr>
        <p:spPr>
          <a:xfrm>
            <a:off x="4247436" y="4230334"/>
            <a:ext cx="962023" cy="1216241"/>
          </a:xfrm>
          <a:prstGeom prst="arc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E"/>
          </a:p>
        </p:txBody>
      </p:sp>
      <p:sp>
        <p:nvSpPr>
          <p:cNvPr id="25" name="Arc 24">
            <a:extLst>
              <a:ext uri="{FF2B5EF4-FFF2-40B4-BE49-F238E27FC236}">
                <a16:creationId xmlns:a16="http://schemas.microsoft.com/office/drawing/2014/main" id="{CA3920AA-CBC0-78C4-51D4-FC0B7F3188BF}"/>
              </a:ext>
            </a:extLst>
          </p:cNvPr>
          <p:cNvSpPr/>
          <p:nvPr/>
        </p:nvSpPr>
        <p:spPr>
          <a:xfrm>
            <a:off x="6458393" y="5359909"/>
            <a:ext cx="962023" cy="1216241"/>
          </a:xfrm>
          <a:prstGeom prst="arc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E"/>
          </a:p>
        </p:txBody>
      </p:sp>
      <p:sp>
        <p:nvSpPr>
          <p:cNvPr id="26" name="Isosceles Triangle 25">
            <a:extLst>
              <a:ext uri="{FF2B5EF4-FFF2-40B4-BE49-F238E27FC236}">
                <a16:creationId xmlns:a16="http://schemas.microsoft.com/office/drawing/2014/main" id="{26427D30-5D5F-DE3D-CB11-C87788705F23}"/>
              </a:ext>
            </a:extLst>
          </p:cNvPr>
          <p:cNvSpPr/>
          <p:nvPr/>
        </p:nvSpPr>
        <p:spPr>
          <a:xfrm rot="10800000">
            <a:off x="5132381" y="4795178"/>
            <a:ext cx="154155" cy="164326"/>
          </a:xfrm>
          <a:prstGeom prst="triangl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E"/>
          </a:p>
        </p:txBody>
      </p:sp>
      <p:sp>
        <p:nvSpPr>
          <p:cNvPr id="27" name="Isosceles Triangle 26">
            <a:extLst>
              <a:ext uri="{FF2B5EF4-FFF2-40B4-BE49-F238E27FC236}">
                <a16:creationId xmlns:a16="http://schemas.microsoft.com/office/drawing/2014/main" id="{7C8B8F3D-54B9-8E57-9BD2-4D31BCAB083C}"/>
              </a:ext>
            </a:extLst>
          </p:cNvPr>
          <p:cNvSpPr/>
          <p:nvPr/>
        </p:nvSpPr>
        <p:spPr>
          <a:xfrm rot="10800000">
            <a:off x="7343337" y="5968029"/>
            <a:ext cx="154155" cy="164326"/>
          </a:xfrm>
          <a:prstGeom prst="triangl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E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46740FA-F3A6-E751-DB3F-0342DB8BEA1D}"/>
              </a:ext>
            </a:extLst>
          </p:cNvPr>
          <p:cNvSpPr txBox="1"/>
          <p:nvPr/>
        </p:nvSpPr>
        <p:spPr>
          <a:xfrm>
            <a:off x="2572716" y="3799490"/>
            <a:ext cx="9909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1.2 mins</a:t>
            </a:r>
            <a:endParaRPr lang="en-AE" b="1" dirty="0">
              <a:solidFill>
                <a:srgbClr val="FF0000"/>
              </a:solidFill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78812E7-F834-F420-BC6C-161D4B86D35D}"/>
              </a:ext>
            </a:extLst>
          </p:cNvPr>
          <p:cNvSpPr txBox="1"/>
          <p:nvPr/>
        </p:nvSpPr>
        <p:spPr>
          <a:xfrm>
            <a:off x="4713969" y="5077243"/>
            <a:ext cx="9909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1.3 mins</a:t>
            </a:r>
            <a:endParaRPr lang="en-AE" b="1" dirty="0">
              <a:solidFill>
                <a:srgbClr val="FF0000"/>
              </a:solidFill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FEAADAB-772D-1834-1B0B-2AC6F16745CF}"/>
              </a:ext>
            </a:extLst>
          </p:cNvPr>
          <p:cNvSpPr txBox="1"/>
          <p:nvPr/>
        </p:nvSpPr>
        <p:spPr>
          <a:xfrm>
            <a:off x="7038384" y="6050192"/>
            <a:ext cx="9909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3.1 mins</a:t>
            </a:r>
            <a:endParaRPr lang="en-AE" b="1" dirty="0">
              <a:solidFill>
                <a:srgbClr val="FF0000"/>
              </a:solidFill>
            </a:endParaRP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3E0A906A-FAE3-3BB3-A905-DB0F7457BF5C}"/>
              </a:ext>
            </a:extLst>
          </p:cNvPr>
          <p:cNvCxnSpPr>
            <a:stCxn id="20" idx="1"/>
            <a:endCxn id="20" idx="1"/>
          </p:cNvCxnSpPr>
          <p:nvPr/>
        </p:nvCxnSpPr>
        <p:spPr>
          <a:xfrm>
            <a:off x="10722455" y="4501247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60A24B5E-7C99-743B-3DD1-3A7DB69A7B5A}"/>
              </a:ext>
            </a:extLst>
          </p:cNvPr>
          <p:cNvCxnSpPr/>
          <p:nvPr/>
        </p:nvCxnSpPr>
        <p:spPr>
          <a:xfrm>
            <a:off x="10722454" y="4546151"/>
            <a:ext cx="0" cy="133219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Isosceles Triangle 35">
            <a:extLst>
              <a:ext uri="{FF2B5EF4-FFF2-40B4-BE49-F238E27FC236}">
                <a16:creationId xmlns:a16="http://schemas.microsoft.com/office/drawing/2014/main" id="{A6348809-FF0D-A0B3-0833-424FCF539EBC}"/>
              </a:ext>
            </a:extLst>
          </p:cNvPr>
          <p:cNvSpPr/>
          <p:nvPr/>
        </p:nvSpPr>
        <p:spPr>
          <a:xfrm rot="10800000">
            <a:off x="10645376" y="5821198"/>
            <a:ext cx="154155" cy="164326"/>
          </a:xfrm>
          <a:prstGeom prst="triangl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E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BDC7DF6-2461-281D-2362-626EA71F5DF0}"/>
              </a:ext>
            </a:extLst>
          </p:cNvPr>
          <p:cNvSpPr txBox="1"/>
          <p:nvPr/>
        </p:nvSpPr>
        <p:spPr>
          <a:xfrm>
            <a:off x="10304042" y="6002936"/>
            <a:ext cx="9909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5.7 mins</a:t>
            </a:r>
            <a:endParaRPr lang="en-AE" b="1" dirty="0">
              <a:solidFill>
                <a:srgbClr val="FF0000"/>
              </a:solidFill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2603FA1-6FC4-C0FE-7595-FEAC7CF66488}"/>
              </a:ext>
            </a:extLst>
          </p:cNvPr>
          <p:cNvSpPr txBox="1"/>
          <p:nvPr/>
        </p:nvSpPr>
        <p:spPr>
          <a:xfrm>
            <a:off x="543463" y="181155"/>
            <a:ext cx="1036365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5: Reduction in Patient Waiting Times at Different Stages of Care Following AI Program Implementation in Primary Healthcare Centers, UAE</a:t>
            </a:r>
            <a:endParaRPr lang="en-AE" b="1" dirty="0"/>
          </a:p>
        </p:txBody>
      </p:sp>
    </p:spTree>
    <p:extLst>
      <p:ext uri="{BB962C8B-B14F-4D97-AF65-F5344CB8AC3E}">
        <p14:creationId xmlns:p14="http://schemas.microsoft.com/office/powerpoint/2010/main" val="1166691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b1851626-05c4-426e-b768-1c35733f6fea}" enabled="1" method="Standard" siteId="{fbc493a8-0d24-4454-a815-f4ca58e8c09d}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46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qvi, Sadaf</dc:creator>
  <cp:lastModifiedBy>Sadaf Naqvi</cp:lastModifiedBy>
  <cp:revision>1</cp:revision>
  <dcterms:created xsi:type="dcterms:W3CDTF">2023-08-04T10:11:29Z</dcterms:created>
  <dcterms:modified xsi:type="dcterms:W3CDTF">2024-11-14T09:28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3c76ce46-357f-46de-88d6-77b9bbb83c46_Enabled">
    <vt:lpwstr>true</vt:lpwstr>
  </property>
  <property fmtid="{D5CDD505-2E9C-101B-9397-08002B2CF9AE}" pid="3" name="MSIP_Label_3c76ce46-357f-46de-88d6-77b9bbb83c46_SetDate">
    <vt:lpwstr>2024-08-12T05:50:10Z</vt:lpwstr>
  </property>
  <property fmtid="{D5CDD505-2E9C-101B-9397-08002B2CF9AE}" pid="4" name="MSIP_Label_3c76ce46-357f-46de-88d6-77b9bbb83c46_Method">
    <vt:lpwstr>Privileged</vt:lpwstr>
  </property>
  <property fmtid="{D5CDD505-2E9C-101B-9397-08002B2CF9AE}" pid="5" name="MSIP_Label_3c76ce46-357f-46de-88d6-77b9bbb83c46_Name">
    <vt:lpwstr>Public</vt:lpwstr>
  </property>
  <property fmtid="{D5CDD505-2E9C-101B-9397-08002B2CF9AE}" pid="6" name="MSIP_Label_3c76ce46-357f-46de-88d6-77b9bbb83c46_SiteId">
    <vt:lpwstr>4e2c6054-71cb-48f1-bd6c-3a9705aca71b</vt:lpwstr>
  </property>
  <property fmtid="{D5CDD505-2E9C-101B-9397-08002B2CF9AE}" pid="7" name="MSIP_Label_3c76ce46-357f-46de-88d6-77b9bbb83c46_ActionId">
    <vt:lpwstr>69feeb87-3d6d-4ffd-8e74-56cf29f948f7</vt:lpwstr>
  </property>
  <property fmtid="{D5CDD505-2E9C-101B-9397-08002B2CF9AE}" pid="8" name="MSIP_Label_3c76ce46-357f-46de-88d6-77b9bbb83c46_ContentBits">
    <vt:lpwstr>0</vt:lpwstr>
  </property>
</Properties>
</file>